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65" r:id="rId4"/>
    <p:sldId id="26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17" autoAdjust="0"/>
    <p:restoredTop sz="94660"/>
  </p:normalViewPr>
  <p:slideViewPr>
    <p:cSldViewPr snapToGrid="0">
      <p:cViewPr>
        <p:scale>
          <a:sx n="90" d="100"/>
          <a:sy n="90" d="100"/>
        </p:scale>
        <p:origin x="1224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52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850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992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953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5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2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71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120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65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817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145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869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0264AE-A719-A84D-3A65-669393FC13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1557084"/>
            <a:ext cx="12192000" cy="4351338"/>
          </a:xfrm>
        </p:spPr>
        <p:txBody>
          <a:bodyPr>
            <a:normAutofit/>
          </a:bodyPr>
          <a:lstStyle/>
          <a:p>
            <a:pPr marL="0" indent="0" algn="ctr">
              <a:lnSpc>
                <a:spcPct val="200000"/>
              </a:lnSpc>
              <a:buNone/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1: Figure S4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nstration of important signaling pathways including 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ippo signaling pathway – fly, the Oxytocin signaling pathway, 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tight junction pathway</a:t>
            </a:r>
          </a:p>
          <a:p>
            <a:pPr marL="0" indent="0" algn="ctr">
              <a:lnSpc>
                <a:spcPct val="200000"/>
              </a:lnSpc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5300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9713B8B-F323-27CB-1720-C84071C8DE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5329" y="171243"/>
            <a:ext cx="7134135" cy="565525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E0E9713-8EA9-7589-1F3C-EF00E0665B55}"/>
              </a:ext>
            </a:extLst>
          </p:cNvPr>
          <p:cNvSpPr txBox="1"/>
          <p:nvPr/>
        </p:nvSpPr>
        <p:spPr>
          <a:xfrm>
            <a:off x="988920" y="5948092"/>
            <a:ext cx="1046432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Hippo signaling pathway – fly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with DEGs shared between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germinal zone of the testis)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the germinal zone of the ovary) tissues are indicated by yellow shading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ssues have green (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tropin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RERE, ID:K05628) and cyan (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PKC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PRKCI, ID:K06069) shading, respectively. The complete list of significant DEGs annotated in KEGG enrichment are shown in 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0: Table S7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en-TH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8820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3FA5050-8532-C6AC-A9FB-02F89AF6F9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0137" y="131524"/>
            <a:ext cx="7487423" cy="552535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3D4C4B7-58AE-1273-6B3F-9BA32F61C6CB}"/>
              </a:ext>
            </a:extLst>
          </p:cNvPr>
          <p:cNvSpPr txBox="1"/>
          <p:nvPr/>
        </p:nvSpPr>
        <p:spPr>
          <a:xfrm>
            <a:off x="1024508" y="5772369"/>
            <a:ext cx="10475235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Oxytocin signaling pathway and DEGs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Yellow shading represents the DEGs that are found in all three tissue samples including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the germinal zone of the ovary),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ovary, part of the oviduct)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seminal vesicle) tissues. DEGs shared only between the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ssue samples are represented by green shading. The violet (GNAQ), orange (EEF2), and cyan (PRKCA) shading were found to be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g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specific, respectively. The complete list of significant DEGs annotated in KEGG enrichment are shown in 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0: Table S7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en-TH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8554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3D5AD58-9959-9664-3404-4715615654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2060" y="141919"/>
            <a:ext cx="6030927" cy="559704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EFA52D0-3BFA-9E93-1ED4-1DD2ED0CCEE4}"/>
              </a:ext>
            </a:extLst>
          </p:cNvPr>
          <p:cNvSpPr txBox="1"/>
          <p:nvPr/>
        </p:nvSpPr>
        <p:spPr>
          <a:xfrm>
            <a:off x="880441" y="5819126"/>
            <a:ext cx="10431118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tight junction pathway and DEGs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Yellow shading represents the DEGs found in all three tissue samples including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ovary, part of the oviduct), Ut (uterus)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seminal vesicle) tissues. The green shading represents DEGs only shared between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ssue samples. Cyan shading were genes discovered exclusively in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v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ssue sample. The complete list of significant DEGs annotated in KEGG enrichment are shown in 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0: Table S7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en-TH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0078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0</TotalTime>
  <Words>311</Words>
  <Application>Microsoft Macintosh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Orawan Phuphisut</cp:lastModifiedBy>
  <cp:revision>48</cp:revision>
  <dcterms:created xsi:type="dcterms:W3CDTF">2022-05-10T17:55:01Z</dcterms:created>
  <dcterms:modified xsi:type="dcterms:W3CDTF">2022-10-23T03:13:14Z</dcterms:modified>
</cp:coreProperties>
</file>